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E6487E-0DB0-47D9-BEC0-0729D763DC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AE181-7027-4E67-A7F2-2CBFB0E9CC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8406F-C404-4F69-8B30-5108E1073A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F8ECC-B258-45A4-8CD3-6887ADFA04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65CCD-CC7F-4800-B95C-8A05E9E1A0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7DD10-E725-4961-9DC3-AE71741AC7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7D8A3-E4A0-492A-975C-D5100E7F79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2A34D-A7A5-499D-9363-716A2FADD3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C6988-6263-46F0-8958-5415C5A337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81333-C9D8-4A84-886A-C9A601566A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47547-FD85-4A91-BF6E-C7BAC7AD13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C8883-344F-469F-BFEB-6AAC57EC40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AF1CAE-C378-4ADA-B50B-39C0CEA9835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"/>
          <p:cNvSpPr/>
          <p:nvPr/>
        </p:nvSpPr>
        <p:spPr>
          <a:xfrm>
            <a:off x="319320" y="227160"/>
            <a:ext cx="2923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Tabl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3"/>
          <p:cNvSpPr/>
          <p:nvPr/>
        </p:nvSpPr>
        <p:spPr>
          <a:xfrm>
            <a:off x="2711880" y="764280"/>
            <a:ext cx="484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Construct Vector Insert Sequence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23"/>
          <p:cNvGrpSpPr/>
          <p:nvPr/>
        </p:nvGrpSpPr>
        <p:grpSpPr>
          <a:xfrm>
            <a:off x="1186920" y="1413000"/>
            <a:ext cx="7419240" cy="1054080"/>
            <a:chOff x="1186920" y="1413000"/>
            <a:chExt cx="7419240" cy="1054080"/>
          </a:xfrm>
        </p:grpSpPr>
        <p:sp>
          <p:nvSpPr>
            <p:cNvPr id="44" name="Rectangle 4"/>
            <p:cNvSpPr/>
            <p:nvPr/>
          </p:nvSpPr>
          <p:spPr>
            <a:xfrm>
              <a:off x="1290240" y="1736640"/>
              <a:ext cx="7315920" cy="73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ttgactcgggccttagaactttgcatagcagctgctactagctctttgagataat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ca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tccga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ggggctcagttctgccttatctaaatcaccag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gaccaaa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caaggactaatcc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acctcttggattttatttaatgtcataatgttgtcagaataaagagaaagatgaaat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14"/>
            <p:cNvSpPr/>
            <p:nvPr/>
          </p:nvSpPr>
          <p:spPr>
            <a:xfrm>
              <a:off x="1186920" y="1413000"/>
              <a:ext cx="3472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Insert sequence (Wild type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Group 20"/>
          <p:cNvGrpSpPr/>
          <p:nvPr/>
        </p:nvGrpSpPr>
        <p:grpSpPr>
          <a:xfrm>
            <a:off x="1212480" y="2757600"/>
            <a:ext cx="7393680" cy="1054080"/>
            <a:chOff x="1212480" y="2757600"/>
            <a:chExt cx="7393680" cy="1054080"/>
          </a:xfrm>
        </p:grpSpPr>
        <p:sp>
          <p:nvSpPr>
            <p:cNvPr id="47" name="Rectangle 5"/>
            <p:cNvSpPr/>
            <p:nvPr/>
          </p:nvSpPr>
          <p:spPr>
            <a:xfrm>
              <a:off x="1290240" y="3081240"/>
              <a:ext cx="7315920" cy="73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ttgactcgggccttagaactttgcatagcagctgctactagctctttgagataat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--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ggggctcagttctgccttatctaaatcaccag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gaccaaa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caaggactaatcc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acctcttggattttatttaatgtcataatgttgtcagaataaagagaaagatgaaat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5"/>
            <p:cNvSpPr/>
            <p:nvPr/>
          </p:nvSpPr>
          <p:spPr>
            <a:xfrm>
              <a:off x="1212480" y="2757600"/>
              <a:ext cx="23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365-371nt dele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Group 21"/>
          <p:cNvGrpSpPr/>
          <p:nvPr/>
        </p:nvGrpSpPr>
        <p:grpSpPr>
          <a:xfrm>
            <a:off x="1212480" y="4102200"/>
            <a:ext cx="7393680" cy="1076040"/>
            <a:chOff x="1212480" y="4102200"/>
            <a:chExt cx="7393680" cy="1076040"/>
          </a:xfrm>
        </p:grpSpPr>
        <p:sp>
          <p:nvSpPr>
            <p:cNvPr id="50" name="Rectangle 6"/>
            <p:cNvSpPr/>
            <p:nvPr/>
          </p:nvSpPr>
          <p:spPr>
            <a:xfrm>
              <a:off x="1290240" y="4447800"/>
              <a:ext cx="7315920" cy="73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ttgactcgggccttagaactttgcatagcagctgctactagctctttgagataat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ca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tccga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ggggctcagttctgccttatctaaatcaccag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----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caaggactaatcc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acctcttggattttatttaatgtcataatgttgtcagaataaagagaaagatgaaat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6"/>
            <p:cNvSpPr/>
            <p:nvPr/>
          </p:nvSpPr>
          <p:spPr>
            <a:xfrm>
              <a:off x="1212480" y="4102200"/>
              <a:ext cx="237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407-413nt dele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oup 22"/>
          <p:cNvGrpSpPr/>
          <p:nvPr/>
        </p:nvGrpSpPr>
        <p:grpSpPr>
          <a:xfrm>
            <a:off x="1215000" y="5468760"/>
            <a:ext cx="7391160" cy="1053000"/>
            <a:chOff x="1215000" y="5468760"/>
            <a:chExt cx="7391160" cy="1053000"/>
          </a:xfrm>
        </p:grpSpPr>
        <p:sp>
          <p:nvSpPr>
            <p:cNvPr id="53" name="Rectangle 7"/>
            <p:cNvSpPr/>
            <p:nvPr/>
          </p:nvSpPr>
          <p:spPr>
            <a:xfrm>
              <a:off x="1290240" y="5791320"/>
              <a:ext cx="7315920" cy="73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ttgactcgggccttagaactttgcatagcagctgctactagctctttgagataat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--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ggggctcagttctgccttatctaaatcaccaga</a:t>
              </a:r>
              <a:r>
                <a:rPr b="1" lang="en-US" sz="1600" spc="-1" strike="noStrike">
                  <a:solidFill>
                    <a:srgbClr val="cc3300"/>
                  </a:solidFill>
                  <a:latin typeface="Courier New"/>
                </a:rPr>
                <a:t>-------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caaggactaatcc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tacctcttggattttatttaatgtcataatgttgtcagaataaagagaaagatgaaata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7"/>
            <p:cNvSpPr/>
            <p:nvPr/>
          </p:nvSpPr>
          <p:spPr>
            <a:xfrm>
              <a:off x="1215000" y="5468760"/>
              <a:ext cx="4082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</a:rPr>
                <a:t>365-371nt and 407-413nt dele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0T04:11:34Z</dcterms:created>
  <dc:creator>Functional Genomics</dc:creator>
  <dc:description/>
  <dc:language>en-US</dc:language>
  <cp:lastModifiedBy>Nijiro Nohata</cp:lastModifiedBy>
  <dcterms:modified xsi:type="dcterms:W3CDTF">2011-09-27T04:30:31Z</dcterms:modified>
  <cp:revision>76</cp:revision>
  <dc:subject/>
  <dc:title>スライド 1</dc:title>
</cp:coreProperties>
</file>